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1836D-6979-46A6-846D-AC0D876A5C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0088C-35AC-473D-B24F-0E5C36BAD5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F4FD2-E294-4606-928D-FC822E6072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0B68B-7F25-449B-B300-EA347DB7C5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D15AE-D0B0-4394-BC97-6A90720685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3BFF3-F281-4F5F-9865-F7DA8B3F8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E73EB-6342-4CDB-9C09-517F2432BA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2360B-1F8A-4AD2-8FE8-028988A3BB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926A3-10C8-4441-9A7E-ECB29B3232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D5137-F98C-4A9E-A487-4C95D2EA12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8CBFD-4BC4-437C-9D2E-D6A21A9397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EE498-6D4F-4B8A-848F-63D502C668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3F9FB2-080B-41BA-9239-54DF7D6B4C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557360" y="6192720"/>
            <a:ext cx="3935520" cy="29512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557360" y="3419640"/>
            <a:ext cx="3946680" cy="2960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1593720" y="685800"/>
            <a:ext cx="3918240" cy="2940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390600" y="179280"/>
            <a:ext cx="596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ementary Figure S2. Numbers of female mosquitoes trapped in the MM-X trap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 Experiment 2. (A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An. gambiae s.l.,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B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Culex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pp. (C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ansonia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p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343160" y="9000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330560" y="6396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343160" y="35640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5T14:46:35Z</dcterms:created>
  <dc:creator>dconway</dc:creator>
  <dc:description/>
  <dc:language>en-US</dc:language>
  <cp:lastModifiedBy>dconway</cp:lastModifiedBy>
  <dcterms:modified xsi:type="dcterms:W3CDTF">2009-09-25T15:04:07Z</dcterms:modified>
  <cp:revision>1</cp:revision>
  <dc:subject/>
  <dc:title>Slide 1</dc:title>
</cp:coreProperties>
</file>